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45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0DC54-25E4-4072-B513-DFEC70F7057A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98BE7-E3FC-4FBD-91D1-8C821E6423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3121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0DC54-25E4-4072-B513-DFEC70F7057A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98BE7-E3FC-4FBD-91D1-8C821E6423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27823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0DC54-25E4-4072-B513-DFEC70F7057A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98BE7-E3FC-4FBD-91D1-8C821E6423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91681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0DC54-25E4-4072-B513-DFEC70F7057A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98BE7-E3FC-4FBD-91D1-8C821E6423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45591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0DC54-25E4-4072-B513-DFEC70F7057A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98BE7-E3FC-4FBD-91D1-8C821E6423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75870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0DC54-25E4-4072-B513-DFEC70F7057A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98BE7-E3FC-4FBD-91D1-8C821E6423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99695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0DC54-25E4-4072-B513-DFEC70F7057A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98BE7-E3FC-4FBD-91D1-8C821E6423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7300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0DC54-25E4-4072-B513-DFEC70F7057A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98BE7-E3FC-4FBD-91D1-8C821E6423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85581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0DC54-25E4-4072-B513-DFEC70F7057A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98BE7-E3FC-4FBD-91D1-8C821E6423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809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0DC54-25E4-4072-B513-DFEC70F7057A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98BE7-E3FC-4FBD-91D1-8C821E6423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04847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0DC54-25E4-4072-B513-DFEC70F7057A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98BE7-E3FC-4FBD-91D1-8C821E6423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35507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B0DC54-25E4-4072-B513-DFEC70F7057A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B98BE7-E3FC-4FBD-91D1-8C821E6423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90799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3211" y="1356125"/>
            <a:ext cx="7403426" cy="5384309"/>
          </a:xfrm>
        </p:spPr>
      </p:pic>
      <p:sp>
        <p:nvSpPr>
          <p:cNvPr id="7" name="TextBox 6"/>
          <p:cNvSpPr txBox="1"/>
          <p:nvPr/>
        </p:nvSpPr>
        <p:spPr>
          <a:xfrm>
            <a:off x="6100555" y="1079126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124450" y="890951"/>
            <a:ext cx="6623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IOX2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250uM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634311" y="887856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IOX2 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747072" y="1070044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8666822" y="914811"/>
            <a:ext cx="6623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IOX2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250uM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8191927" y="914811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IOX2 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cxnSp>
        <p:nvCxnSpPr>
          <p:cNvPr id="13" name="Straight Connector 12"/>
          <p:cNvCxnSpPr/>
          <p:nvPr/>
        </p:nvCxnSpPr>
        <p:spPr>
          <a:xfrm>
            <a:off x="7853172" y="879344"/>
            <a:ext cx="1329466" cy="603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8191927" y="524728"/>
            <a:ext cx="6735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TGFb1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414859" y="2750240"/>
            <a:ext cx="827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00421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Content Placeholder 14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7622" y="1347526"/>
            <a:ext cx="7547919" cy="5489398"/>
          </a:xfrm>
        </p:spPr>
      </p:pic>
      <p:sp>
        <p:nvSpPr>
          <p:cNvPr id="7" name="TextBox 6"/>
          <p:cNvSpPr txBox="1"/>
          <p:nvPr/>
        </p:nvSpPr>
        <p:spPr>
          <a:xfrm>
            <a:off x="5512728" y="1070941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536623" y="882766"/>
            <a:ext cx="6623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IOX2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250uM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046484" y="879671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IOX2 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159245" y="1061859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8078995" y="906626"/>
            <a:ext cx="6623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IOX2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250uM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7604100" y="906626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IOX2 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cxnSp>
        <p:nvCxnSpPr>
          <p:cNvPr id="13" name="Straight Connector 12"/>
          <p:cNvCxnSpPr/>
          <p:nvPr/>
        </p:nvCxnSpPr>
        <p:spPr>
          <a:xfrm>
            <a:off x="7265345" y="871159"/>
            <a:ext cx="1329466" cy="603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7604100" y="516543"/>
            <a:ext cx="6735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TGFb1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310357" y="3089874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PLOD2</a:t>
            </a:r>
          </a:p>
        </p:txBody>
      </p:sp>
    </p:spTree>
    <p:extLst>
      <p:ext uri="{BB962C8B-B14F-4D97-AF65-F5344CB8AC3E}">
        <p14:creationId xmlns:p14="http://schemas.microsoft.com/office/powerpoint/2010/main" val="42914455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0740" y="1158223"/>
            <a:ext cx="7747583" cy="5634605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6129992" y="814310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153887" y="626135"/>
            <a:ext cx="6623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IOX2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250uM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663748" y="623040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IOX2 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776509" y="805228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8696259" y="649995"/>
            <a:ext cx="6623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IOX2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250uM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8221364" y="649995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IOX2 </a:t>
            </a: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cxnSp>
        <p:nvCxnSpPr>
          <p:cNvPr id="13" name="Straight Connector 12"/>
          <p:cNvCxnSpPr/>
          <p:nvPr/>
        </p:nvCxnSpPr>
        <p:spPr>
          <a:xfrm>
            <a:off x="7882609" y="614528"/>
            <a:ext cx="1329466" cy="603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8221364" y="259912"/>
            <a:ext cx="6735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TGFb1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214975" y="4513348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462767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8</Words>
  <Application>Microsoft Macintosh PowerPoint</Application>
  <PresentationFormat>Widescreen</PresentationFormat>
  <Paragraphs>3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>University Of Southampt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pher Brereton</dc:creator>
  <cp:lastModifiedBy>Mark Jones</cp:lastModifiedBy>
  <cp:revision>5</cp:revision>
  <dcterms:created xsi:type="dcterms:W3CDTF">2021-05-05T12:56:08Z</dcterms:created>
  <dcterms:modified xsi:type="dcterms:W3CDTF">2021-11-12T15:03:19Z</dcterms:modified>
</cp:coreProperties>
</file>